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1" r:id="rId4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42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-1140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ad\fs\C010-home\sonnet\PhD\Cell%20Sorting\MassARRAY%20results\Prdm16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ad\fs\C010-home\sonnet\PhD\Cell%20Sorting\MassARRAY%20results\Robo3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ad\fs\C010-home\sonnet\PhD\Cell%20Sorting\MassARRAY%20results\Bcor_probe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ad\fs\C010-home\sonnet\PhD\Cell%20Sorting\MassARRAY%20results\Bcor_2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ad\fs\C010-home\sonnet\PhD\Cell%20Sorting\MassARRAY%20results\Hes6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ad\fs\C010-home\sonnet\PhD\Cell%20Sorting\MassARRAY%20results\Tal1_probe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\\ad\fs\C010-home\sonnet\PhD\Cell%20Sorting\MassARRAY%20results\Itpka_2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\\ad\fs\C010-home\sonnet\PhD\Cell%20Sorting\MassARRAY%20results\Itpka_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Prdm16</c:v>
          </c:tx>
          <c:invertIfNegative val="0"/>
          <c:cat>
            <c:strRef>
              <c:f>Prdm16!$G$18:$G$29</c:f>
              <c:strCache>
                <c:ptCount val="12"/>
                <c:pt idx="0">
                  <c:v>WT_LSK</c:v>
                </c:pt>
                <c:pt idx="1">
                  <c:v>WT_CMP</c:v>
                </c:pt>
                <c:pt idx="2">
                  <c:v>WT_GMP</c:v>
                </c:pt>
                <c:pt idx="3">
                  <c:v>WT_MEP</c:v>
                </c:pt>
                <c:pt idx="4">
                  <c:v>KD1_LSK</c:v>
                </c:pt>
                <c:pt idx="5">
                  <c:v>KD1_CMP</c:v>
                </c:pt>
                <c:pt idx="6">
                  <c:v>KD1_GMP</c:v>
                </c:pt>
                <c:pt idx="7">
                  <c:v>KD1_MEP</c:v>
                </c:pt>
                <c:pt idx="8">
                  <c:v>KD2_LSK</c:v>
                </c:pt>
                <c:pt idx="9">
                  <c:v>KD2_CMP</c:v>
                </c:pt>
                <c:pt idx="10">
                  <c:v>KD2_GMP</c:v>
                </c:pt>
                <c:pt idx="11">
                  <c:v>KD2_MEP</c:v>
                </c:pt>
              </c:strCache>
            </c:strRef>
          </c:cat>
          <c:val>
            <c:numRef>
              <c:f>Prdm16!$H$18:$H$29</c:f>
              <c:numCache>
                <c:formatCode>General</c:formatCode>
                <c:ptCount val="12"/>
                <c:pt idx="0">
                  <c:v>0</c:v>
                </c:pt>
                <c:pt idx="1">
                  <c:v>4.5728571428571438</c:v>
                </c:pt>
                <c:pt idx="2">
                  <c:v>4.2157142857142862</c:v>
                </c:pt>
                <c:pt idx="3">
                  <c:v>5.7857142857142874</c:v>
                </c:pt>
                <c:pt idx="4">
                  <c:v>9.4300000000000015</c:v>
                </c:pt>
                <c:pt idx="5">
                  <c:v>9.571428571428573</c:v>
                </c:pt>
                <c:pt idx="6">
                  <c:v>10.714285714285717</c:v>
                </c:pt>
                <c:pt idx="7">
                  <c:v>9.6428571428571441</c:v>
                </c:pt>
                <c:pt idx="8">
                  <c:v>10.071428571428573</c:v>
                </c:pt>
                <c:pt idx="9">
                  <c:v>9.4285714285714306</c:v>
                </c:pt>
                <c:pt idx="10">
                  <c:v>10.142857142857144</c:v>
                </c:pt>
                <c:pt idx="11">
                  <c:v>10.14285714285714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9462272"/>
        <c:axId val="89463808"/>
      </c:barChart>
      <c:catAx>
        <c:axId val="8946227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de-DE"/>
          </a:p>
        </c:txPr>
        <c:crossAx val="89463808"/>
        <c:crosses val="autoZero"/>
        <c:auto val="1"/>
        <c:lblAlgn val="ctr"/>
        <c:lblOffset val="100"/>
        <c:noMultiLvlLbl val="0"/>
      </c:catAx>
      <c:valAx>
        <c:axId val="89463808"/>
        <c:scaling>
          <c:orientation val="minMax"/>
          <c:max val="12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>
                    <a:latin typeface="Arial" pitchFamily="34" charset="0"/>
                    <a:cs typeface="Arial" pitchFamily="34" charset="0"/>
                  </a:defRPr>
                </a:pPr>
                <a:r>
                  <a:rPr lang="en-US" dirty="0">
                    <a:latin typeface="Arial" pitchFamily="34" charset="0"/>
                    <a:cs typeface="Arial" pitchFamily="34" charset="0"/>
                  </a:rPr>
                  <a:t>DNA </a:t>
                </a:r>
                <a:r>
                  <a:rPr lang="en-US" dirty="0" smtClean="0">
                    <a:latin typeface="Arial" pitchFamily="34" charset="0"/>
                    <a:cs typeface="Arial" pitchFamily="34" charset="0"/>
                  </a:rPr>
                  <a:t>Methylation </a:t>
                </a:r>
                <a:r>
                  <a:rPr lang="en-US" dirty="0">
                    <a:latin typeface="Arial" pitchFamily="34" charset="0"/>
                    <a:cs typeface="Arial" pitchFamily="34" charset="0"/>
                  </a:rPr>
                  <a:t>[%]</a:t>
                </a:r>
              </a:p>
            </c:rich>
          </c:tx>
          <c:layout>
            <c:manualLayout>
              <c:xMode val="edge"/>
              <c:yMode val="edge"/>
              <c:x val="2.9411764705882353E-2"/>
              <c:y val="0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de-DE"/>
          </a:p>
        </c:txPr>
        <c:crossAx val="8946227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Robo3</c:v>
          </c:tx>
          <c:invertIfNegative val="0"/>
          <c:cat>
            <c:strRef>
              <c:f>Robo3!$D$19:$D$30</c:f>
              <c:strCache>
                <c:ptCount val="12"/>
                <c:pt idx="0">
                  <c:v>WT_LSK</c:v>
                </c:pt>
                <c:pt idx="1">
                  <c:v>WT_CMP</c:v>
                </c:pt>
                <c:pt idx="2">
                  <c:v>WT_GMP</c:v>
                </c:pt>
                <c:pt idx="3">
                  <c:v>WT_MEP</c:v>
                </c:pt>
                <c:pt idx="4">
                  <c:v>KD1_LSK</c:v>
                </c:pt>
                <c:pt idx="5">
                  <c:v>KD1_CMP</c:v>
                </c:pt>
                <c:pt idx="6">
                  <c:v>KD1_GMP</c:v>
                </c:pt>
                <c:pt idx="7">
                  <c:v>KD1_MEP</c:v>
                </c:pt>
                <c:pt idx="8">
                  <c:v>KD2_LSK</c:v>
                </c:pt>
                <c:pt idx="9">
                  <c:v>KD2_CMP</c:v>
                </c:pt>
                <c:pt idx="10">
                  <c:v>KD2_GMP</c:v>
                </c:pt>
                <c:pt idx="11">
                  <c:v>KD2_MEP</c:v>
                </c:pt>
              </c:strCache>
            </c:strRef>
          </c:cat>
          <c:val>
            <c:numRef>
              <c:f>Robo3!$E$19:$E$30</c:f>
              <c:numCache>
                <c:formatCode>General</c:formatCode>
                <c:ptCount val="12"/>
                <c:pt idx="0">
                  <c:v>42.75</c:v>
                </c:pt>
                <c:pt idx="1">
                  <c:v>49.888888888888886</c:v>
                </c:pt>
                <c:pt idx="2">
                  <c:v>47.333333333333336</c:v>
                </c:pt>
                <c:pt idx="3">
                  <c:v>46.666666666666664</c:v>
                </c:pt>
                <c:pt idx="4">
                  <c:v>67.888888888888886</c:v>
                </c:pt>
                <c:pt idx="5">
                  <c:v>70.888888888888886</c:v>
                </c:pt>
                <c:pt idx="6">
                  <c:v>66.333333333333329</c:v>
                </c:pt>
                <c:pt idx="7">
                  <c:v>65</c:v>
                </c:pt>
                <c:pt idx="8">
                  <c:v>62.111111111111107</c:v>
                </c:pt>
                <c:pt idx="9">
                  <c:v>67.000000000000014</c:v>
                </c:pt>
                <c:pt idx="10">
                  <c:v>56.000000000000007</c:v>
                </c:pt>
                <c:pt idx="11">
                  <c:v>67.44444444444444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3758208"/>
        <c:axId val="93759744"/>
      </c:barChart>
      <c:catAx>
        <c:axId val="9375820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de-DE"/>
          </a:p>
        </c:txPr>
        <c:crossAx val="93759744"/>
        <c:crosses val="autoZero"/>
        <c:auto val="1"/>
        <c:lblAlgn val="ctr"/>
        <c:lblOffset val="100"/>
        <c:noMultiLvlLbl val="0"/>
      </c:catAx>
      <c:valAx>
        <c:axId val="93759744"/>
        <c:scaling>
          <c:orientation val="minMax"/>
          <c:max val="7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>
                    <a:latin typeface="Arial" pitchFamily="34" charset="0"/>
                    <a:cs typeface="Arial" pitchFamily="34" charset="0"/>
                  </a:defRPr>
                </a:pPr>
                <a:r>
                  <a:rPr lang="en-US" dirty="0">
                    <a:latin typeface="Arial" pitchFamily="34" charset="0"/>
                    <a:cs typeface="Arial" pitchFamily="34" charset="0"/>
                  </a:rPr>
                  <a:t>DNA </a:t>
                </a:r>
                <a:r>
                  <a:rPr lang="en-US" dirty="0" smtClean="0">
                    <a:latin typeface="Arial" pitchFamily="34" charset="0"/>
                    <a:cs typeface="Arial" pitchFamily="34" charset="0"/>
                  </a:rPr>
                  <a:t>Methylation </a:t>
                </a:r>
                <a:r>
                  <a:rPr lang="en-US" dirty="0">
                    <a:latin typeface="Arial" pitchFamily="34" charset="0"/>
                    <a:cs typeface="Arial" pitchFamily="34" charset="0"/>
                  </a:rPr>
                  <a:t>[%]</a:t>
                </a:r>
              </a:p>
            </c:rich>
          </c:tx>
          <c:layout>
            <c:manualLayout>
              <c:xMode val="edge"/>
              <c:yMode val="edge"/>
              <c:x val="2.6666666666666668E-2"/>
              <c:y val="0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de-DE"/>
          </a:p>
        </c:txPr>
        <c:crossAx val="9375820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Bcor</c:v>
          </c:tx>
          <c:invertIfNegative val="0"/>
          <c:cat>
            <c:strRef>
              <c:f>Bcor_probe!$E$19:$E$30</c:f>
              <c:strCache>
                <c:ptCount val="12"/>
                <c:pt idx="0">
                  <c:v>WT_LSK</c:v>
                </c:pt>
                <c:pt idx="1">
                  <c:v>WT_CMP</c:v>
                </c:pt>
                <c:pt idx="2">
                  <c:v>WT_GMP</c:v>
                </c:pt>
                <c:pt idx="3">
                  <c:v>WT_MEP</c:v>
                </c:pt>
                <c:pt idx="4">
                  <c:v>KD1_LSK</c:v>
                </c:pt>
                <c:pt idx="5">
                  <c:v>KD1_CMP</c:v>
                </c:pt>
                <c:pt idx="6">
                  <c:v>KD1_GMP</c:v>
                </c:pt>
                <c:pt idx="7">
                  <c:v>KD1_MEP</c:v>
                </c:pt>
                <c:pt idx="8">
                  <c:v>KD2_LSK</c:v>
                </c:pt>
                <c:pt idx="9">
                  <c:v>KD2_CMP</c:v>
                </c:pt>
                <c:pt idx="10">
                  <c:v>KD2_GMP</c:v>
                </c:pt>
                <c:pt idx="11">
                  <c:v>KD2_MEP</c:v>
                </c:pt>
              </c:strCache>
            </c:strRef>
          </c:cat>
          <c:val>
            <c:numRef>
              <c:f>Bcor_probe!$F$19:$F$30</c:f>
              <c:numCache>
                <c:formatCode>General</c:formatCode>
                <c:ptCount val="12"/>
                <c:pt idx="0">
                  <c:v>7.9230769230769234</c:v>
                </c:pt>
                <c:pt idx="1">
                  <c:v>8.9238461538461546</c:v>
                </c:pt>
                <c:pt idx="2">
                  <c:v>8.0849999999999991</c:v>
                </c:pt>
                <c:pt idx="3">
                  <c:v>5.846923076923078</c:v>
                </c:pt>
                <c:pt idx="4">
                  <c:v>17.693076923076923</c:v>
                </c:pt>
                <c:pt idx="5">
                  <c:v>17.999999999999996</c:v>
                </c:pt>
                <c:pt idx="6">
                  <c:v>14.693076923076923</c:v>
                </c:pt>
                <c:pt idx="7">
                  <c:v>17</c:v>
                </c:pt>
                <c:pt idx="8">
                  <c:v>18.384615384615387</c:v>
                </c:pt>
                <c:pt idx="9">
                  <c:v>18.153846153846153</c:v>
                </c:pt>
                <c:pt idx="10">
                  <c:v>19.499999999999996</c:v>
                </c:pt>
                <c:pt idx="11">
                  <c:v>16.92307692307692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3804416"/>
        <c:axId val="93805952"/>
      </c:barChart>
      <c:catAx>
        <c:axId val="9380441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de-DE"/>
          </a:p>
        </c:txPr>
        <c:crossAx val="93805952"/>
        <c:crosses val="autoZero"/>
        <c:auto val="1"/>
        <c:lblAlgn val="ctr"/>
        <c:lblOffset val="100"/>
        <c:noMultiLvlLbl val="0"/>
      </c:catAx>
      <c:valAx>
        <c:axId val="93805952"/>
        <c:scaling>
          <c:orientation val="minMax"/>
          <c:max val="2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>
                    <a:latin typeface="Arial" pitchFamily="34" charset="0"/>
                    <a:cs typeface="Arial" pitchFamily="34" charset="0"/>
                  </a:defRPr>
                </a:pPr>
                <a:r>
                  <a:rPr lang="en-US" dirty="0">
                    <a:latin typeface="Arial" pitchFamily="34" charset="0"/>
                    <a:cs typeface="Arial" pitchFamily="34" charset="0"/>
                  </a:rPr>
                  <a:t>DNA </a:t>
                </a:r>
                <a:r>
                  <a:rPr lang="en-US" dirty="0" smtClean="0">
                    <a:latin typeface="Arial" pitchFamily="34" charset="0"/>
                    <a:cs typeface="Arial" pitchFamily="34" charset="0"/>
                  </a:rPr>
                  <a:t>Methylation </a:t>
                </a:r>
                <a:r>
                  <a:rPr lang="en-US" dirty="0">
                    <a:latin typeface="Arial" pitchFamily="34" charset="0"/>
                    <a:cs typeface="Arial" pitchFamily="34" charset="0"/>
                  </a:rPr>
                  <a:t>[%]</a:t>
                </a:r>
              </a:p>
            </c:rich>
          </c:tx>
          <c:layout>
            <c:manualLayout>
              <c:xMode val="edge"/>
              <c:yMode val="edge"/>
              <c:x val="2.7272727272727271E-2"/>
              <c:y val="2.2768670309653915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de-DE"/>
          </a:p>
        </c:txPr>
        <c:crossAx val="9380441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Bcor_2</c:v>
          </c:tx>
          <c:invertIfNegative val="0"/>
          <c:cat>
            <c:strRef>
              <c:f>Bcor_2!$D$17:$D$28</c:f>
              <c:strCache>
                <c:ptCount val="12"/>
                <c:pt idx="0">
                  <c:v>WT_LSK</c:v>
                </c:pt>
                <c:pt idx="1">
                  <c:v>WT_CMP</c:v>
                </c:pt>
                <c:pt idx="2">
                  <c:v>WT_GMP</c:v>
                </c:pt>
                <c:pt idx="3">
                  <c:v>WT_MEP</c:v>
                </c:pt>
                <c:pt idx="4">
                  <c:v>KD1_LSK</c:v>
                </c:pt>
                <c:pt idx="5">
                  <c:v>KD1_CMP</c:v>
                </c:pt>
                <c:pt idx="6">
                  <c:v>KD1_GMP</c:v>
                </c:pt>
                <c:pt idx="7">
                  <c:v>KD1_MEP</c:v>
                </c:pt>
                <c:pt idx="8">
                  <c:v>KD2_LSK</c:v>
                </c:pt>
                <c:pt idx="9">
                  <c:v>KD2_CMP</c:v>
                </c:pt>
                <c:pt idx="10">
                  <c:v>KD2_GMP</c:v>
                </c:pt>
                <c:pt idx="11">
                  <c:v>KD2_MEP</c:v>
                </c:pt>
              </c:strCache>
            </c:strRef>
          </c:cat>
          <c:val>
            <c:numRef>
              <c:f>Bcor_2!$E$17:$E$28</c:f>
              <c:numCache>
                <c:formatCode>General</c:formatCode>
                <c:ptCount val="12"/>
                <c:pt idx="0">
                  <c:v>18.000000000000004</c:v>
                </c:pt>
                <c:pt idx="1">
                  <c:v>0.505</c:v>
                </c:pt>
                <c:pt idx="2">
                  <c:v>14.399999999999999</c:v>
                </c:pt>
                <c:pt idx="3">
                  <c:v>22.400000000000002</c:v>
                </c:pt>
                <c:pt idx="4">
                  <c:v>43.999999999999993</c:v>
                </c:pt>
                <c:pt idx="5">
                  <c:v>46.999999999999993</c:v>
                </c:pt>
                <c:pt idx="6">
                  <c:v>40</c:v>
                </c:pt>
                <c:pt idx="7">
                  <c:v>41.8</c:v>
                </c:pt>
                <c:pt idx="8">
                  <c:v>43.8</c:v>
                </c:pt>
                <c:pt idx="9">
                  <c:v>28.799999999999997</c:v>
                </c:pt>
                <c:pt idx="10">
                  <c:v>40.199999999999996</c:v>
                </c:pt>
                <c:pt idx="11">
                  <c:v>3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3817856"/>
        <c:axId val="93827840"/>
      </c:barChart>
      <c:catAx>
        <c:axId val="9381785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de-DE"/>
          </a:p>
        </c:txPr>
        <c:crossAx val="93827840"/>
        <c:crosses val="autoZero"/>
        <c:auto val="1"/>
        <c:lblAlgn val="ctr"/>
        <c:lblOffset val="100"/>
        <c:noMultiLvlLbl val="0"/>
      </c:catAx>
      <c:valAx>
        <c:axId val="93827840"/>
        <c:scaling>
          <c:orientation val="minMax"/>
          <c:max val="5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>
                    <a:latin typeface="Arial" pitchFamily="34" charset="0"/>
                    <a:cs typeface="Arial" pitchFamily="34" charset="0"/>
                  </a:defRPr>
                </a:pPr>
                <a:r>
                  <a:rPr lang="en-US" dirty="0">
                    <a:latin typeface="Arial" pitchFamily="34" charset="0"/>
                    <a:cs typeface="Arial" pitchFamily="34" charset="0"/>
                  </a:rPr>
                  <a:t>DNA </a:t>
                </a:r>
                <a:r>
                  <a:rPr lang="en-US" dirty="0" smtClean="0">
                    <a:latin typeface="Arial" pitchFamily="34" charset="0"/>
                    <a:cs typeface="Arial" pitchFamily="34" charset="0"/>
                  </a:rPr>
                  <a:t>Methylation </a:t>
                </a:r>
                <a:r>
                  <a:rPr lang="en-US" dirty="0">
                    <a:latin typeface="Arial" pitchFamily="34" charset="0"/>
                    <a:cs typeface="Arial" pitchFamily="34" charset="0"/>
                  </a:rPr>
                  <a:t>[%]</a:t>
                </a:r>
              </a:p>
            </c:rich>
          </c:tx>
          <c:layout>
            <c:manualLayout>
              <c:xMode val="edge"/>
              <c:yMode val="edge"/>
              <c:x val="2.6765058111261505E-2"/>
              <c:y val="3.794778384942319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de-DE"/>
          </a:p>
        </c:txPr>
        <c:crossAx val="9381785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Hes6</c:v>
          </c:tx>
          <c:invertIfNegative val="0"/>
          <c:cat>
            <c:strRef>
              <c:f>'Hes6'!$D$20:$D$31</c:f>
              <c:strCache>
                <c:ptCount val="12"/>
                <c:pt idx="0">
                  <c:v>WT_LSK</c:v>
                </c:pt>
                <c:pt idx="1">
                  <c:v>WT_CMP</c:v>
                </c:pt>
                <c:pt idx="2">
                  <c:v>WT_GMP</c:v>
                </c:pt>
                <c:pt idx="3">
                  <c:v>WT_MEP</c:v>
                </c:pt>
                <c:pt idx="4">
                  <c:v>KD1_LSK</c:v>
                </c:pt>
                <c:pt idx="5">
                  <c:v>KD1_CMP</c:v>
                </c:pt>
                <c:pt idx="6">
                  <c:v>KD1_GMP</c:v>
                </c:pt>
                <c:pt idx="7">
                  <c:v>KD1_MEP</c:v>
                </c:pt>
                <c:pt idx="8">
                  <c:v>KD2_LSK</c:v>
                </c:pt>
                <c:pt idx="9">
                  <c:v>KD2_CMP</c:v>
                </c:pt>
                <c:pt idx="10">
                  <c:v>KD2_GMP</c:v>
                </c:pt>
                <c:pt idx="11">
                  <c:v>KD2_MEP</c:v>
                </c:pt>
              </c:strCache>
            </c:strRef>
          </c:cat>
          <c:val>
            <c:numRef>
              <c:f>'Hes6'!$E$20:$E$31</c:f>
              <c:numCache>
                <c:formatCode>General</c:formatCode>
                <c:ptCount val="12"/>
                <c:pt idx="0">
                  <c:v>17.714285714285719</c:v>
                </c:pt>
                <c:pt idx="1">
                  <c:v>0</c:v>
                </c:pt>
                <c:pt idx="2">
                  <c:v>15.428571428571431</c:v>
                </c:pt>
                <c:pt idx="3">
                  <c:v>13.999999999999998</c:v>
                </c:pt>
                <c:pt idx="4">
                  <c:v>29.142857142857142</c:v>
                </c:pt>
                <c:pt idx="5">
                  <c:v>25.142857142857146</c:v>
                </c:pt>
                <c:pt idx="6">
                  <c:v>23.857142857142851</c:v>
                </c:pt>
                <c:pt idx="7">
                  <c:v>25.857142857142858</c:v>
                </c:pt>
                <c:pt idx="8">
                  <c:v>30.571428571428566</c:v>
                </c:pt>
                <c:pt idx="9">
                  <c:v>24.714285714285715</c:v>
                </c:pt>
                <c:pt idx="10">
                  <c:v>24.142857142857139</c:v>
                </c:pt>
                <c:pt idx="11">
                  <c:v>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5349120"/>
        <c:axId val="105350656"/>
      </c:barChart>
      <c:catAx>
        <c:axId val="10534912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de-DE"/>
          </a:p>
        </c:txPr>
        <c:crossAx val="105350656"/>
        <c:crosses val="autoZero"/>
        <c:auto val="1"/>
        <c:lblAlgn val="ctr"/>
        <c:lblOffset val="100"/>
        <c:noMultiLvlLbl val="0"/>
      </c:catAx>
      <c:valAx>
        <c:axId val="105350656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>
                    <a:latin typeface="Arial" pitchFamily="34" charset="0"/>
                    <a:cs typeface="Arial" pitchFamily="34" charset="0"/>
                  </a:defRPr>
                </a:pPr>
                <a:r>
                  <a:rPr lang="en-US" dirty="0">
                    <a:latin typeface="Arial" pitchFamily="34" charset="0"/>
                    <a:cs typeface="Arial" pitchFamily="34" charset="0"/>
                  </a:rPr>
                  <a:t>DNA </a:t>
                </a:r>
                <a:r>
                  <a:rPr lang="en-US" dirty="0" smtClean="0">
                    <a:latin typeface="Arial" pitchFamily="34" charset="0"/>
                    <a:cs typeface="Arial" pitchFamily="34" charset="0"/>
                  </a:rPr>
                  <a:t>Methylation </a:t>
                </a:r>
                <a:r>
                  <a:rPr lang="en-US" dirty="0">
                    <a:latin typeface="Arial" pitchFamily="34" charset="0"/>
                    <a:cs typeface="Arial" pitchFamily="34" charset="0"/>
                  </a:rPr>
                  <a:t>[%]</a:t>
                </a:r>
              </a:p>
            </c:rich>
          </c:tx>
          <c:layout>
            <c:manualLayout>
              <c:xMode val="edge"/>
              <c:yMode val="edge"/>
              <c:x val="3.5752873883567245E-2"/>
              <c:y val="4.0551241442730153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de-DE"/>
          </a:p>
        </c:txPr>
        <c:crossAx val="105349120"/>
        <c:crosses val="autoZero"/>
        <c:crossBetween val="between"/>
        <c:majorUnit val="10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Tal1_probe</c:v>
          </c:tx>
          <c:invertIfNegative val="0"/>
          <c:cat>
            <c:strRef>
              <c:f>Tal1_probe!$F$19:$F$30</c:f>
              <c:strCache>
                <c:ptCount val="12"/>
                <c:pt idx="0">
                  <c:v>WT_LSK</c:v>
                </c:pt>
                <c:pt idx="1">
                  <c:v>WT_CMP</c:v>
                </c:pt>
                <c:pt idx="2">
                  <c:v>WT_GMP</c:v>
                </c:pt>
                <c:pt idx="3">
                  <c:v>WT_MEP</c:v>
                </c:pt>
                <c:pt idx="4">
                  <c:v>KD1_LSK</c:v>
                </c:pt>
                <c:pt idx="5">
                  <c:v>KD1_CMP</c:v>
                </c:pt>
                <c:pt idx="6">
                  <c:v>KD1_GMP</c:v>
                </c:pt>
                <c:pt idx="7">
                  <c:v>KD1_MEP</c:v>
                </c:pt>
                <c:pt idx="8">
                  <c:v>KD2_LSK</c:v>
                </c:pt>
                <c:pt idx="9">
                  <c:v>KD2_CMP</c:v>
                </c:pt>
                <c:pt idx="10">
                  <c:v>KD2_GMP</c:v>
                </c:pt>
                <c:pt idx="11">
                  <c:v>KD2_MEP</c:v>
                </c:pt>
              </c:strCache>
            </c:strRef>
          </c:cat>
          <c:val>
            <c:numRef>
              <c:f>Tal1_probe!$G$19:$G$30</c:f>
              <c:numCache>
                <c:formatCode>General</c:formatCode>
                <c:ptCount val="12"/>
                <c:pt idx="0">
                  <c:v>4.6938461538461551</c:v>
                </c:pt>
                <c:pt idx="1">
                  <c:v>4.0023076923076921</c:v>
                </c:pt>
                <c:pt idx="2">
                  <c:v>4.4630769230769243</c:v>
                </c:pt>
                <c:pt idx="3">
                  <c:v>4.6161538461538472</c:v>
                </c:pt>
                <c:pt idx="4">
                  <c:v>4.1546153846153855</c:v>
                </c:pt>
                <c:pt idx="5">
                  <c:v>5.9246153846153851</c:v>
                </c:pt>
                <c:pt idx="6">
                  <c:v>13.153846153846155</c:v>
                </c:pt>
                <c:pt idx="7">
                  <c:v>8.0015384615384626</c:v>
                </c:pt>
                <c:pt idx="8">
                  <c:v>6.1546153846153846</c:v>
                </c:pt>
                <c:pt idx="9">
                  <c:v>6.6161538461538463</c:v>
                </c:pt>
                <c:pt idx="10">
                  <c:v>9.846923076923078</c:v>
                </c:pt>
                <c:pt idx="11">
                  <c:v>5.772307692307692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5378944"/>
        <c:axId val="105380480"/>
      </c:barChart>
      <c:catAx>
        <c:axId val="10537894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de-DE"/>
          </a:p>
        </c:txPr>
        <c:crossAx val="105380480"/>
        <c:crosses val="autoZero"/>
        <c:auto val="1"/>
        <c:lblAlgn val="ctr"/>
        <c:lblOffset val="100"/>
        <c:noMultiLvlLbl val="0"/>
      </c:catAx>
      <c:valAx>
        <c:axId val="105380480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>
                    <a:latin typeface="Arial" pitchFamily="34" charset="0"/>
                    <a:cs typeface="Arial" pitchFamily="34" charset="0"/>
                  </a:defRPr>
                </a:pPr>
                <a:r>
                  <a:rPr lang="en-US" dirty="0">
                    <a:latin typeface="Arial" pitchFamily="34" charset="0"/>
                    <a:cs typeface="Arial" pitchFamily="34" charset="0"/>
                  </a:rPr>
                  <a:t>DNA </a:t>
                </a:r>
                <a:r>
                  <a:rPr lang="en-US" dirty="0" smtClean="0">
                    <a:latin typeface="Arial" pitchFamily="34" charset="0"/>
                    <a:cs typeface="Arial" pitchFamily="34" charset="0"/>
                  </a:rPr>
                  <a:t>Methylation </a:t>
                </a:r>
                <a:r>
                  <a:rPr lang="en-US" dirty="0">
                    <a:latin typeface="Arial" pitchFamily="34" charset="0"/>
                    <a:cs typeface="Arial" pitchFamily="34" charset="0"/>
                  </a:rPr>
                  <a:t>[%]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de-DE"/>
          </a:p>
        </c:txPr>
        <c:crossAx val="10537894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Itpka_2</c:v>
          </c:tx>
          <c:invertIfNegative val="0"/>
          <c:cat>
            <c:strRef>
              <c:f>Itpka_2!$D$17:$D$28</c:f>
              <c:strCache>
                <c:ptCount val="12"/>
                <c:pt idx="0">
                  <c:v>WT_LSK</c:v>
                </c:pt>
                <c:pt idx="1">
                  <c:v>WT_CMP</c:v>
                </c:pt>
                <c:pt idx="2">
                  <c:v>WT_GMP</c:v>
                </c:pt>
                <c:pt idx="3">
                  <c:v>WT_MEP</c:v>
                </c:pt>
                <c:pt idx="4">
                  <c:v>KD1_LSK</c:v>
                </c:pt>
                <c:pt idx="5">
                  <c:v>KD1_CMP</c:v>
                </c:pt>
                <c:pt idx="6">
                  <c:v>KD1_GMP</c:v>
                </c:pt>
                <c:pt idx="7">
                  <c:v>KD1_MEP</c:v>
                </c:pt>
                <c:pt idx="8">
                  <c:v>KD2_LSK</c:v>
                </c:pt>
                <c:pt idx="9">
                  <c:v>KD2_CMP</c:v>
                </c:pt>
                <c:pt idx="10">
                  <c:v>KD2_GMP</c:v>
                </c:pt>
                <c:pt idx="11">
                  <c:v>KD2_MEP</c:v>
                </c:pt>
              </c:strCache>
            </c:strRef>
          </c:cat>
          <c:val>
            <c:numRef>
              <c:f>Itpka_2!$E$17:$E$28</c:f>
              <c:numCache>
                <c:formatCode>General</c:formatCode>
                <c:ptCount val="12"/>
                <c:pt idx="0">
                  <c:v>37.571428571428569</c:v>
                </c:pt>
                <c:pt idx="1">
                  <c:v>32.285714285714285</c:v>
                </c:pt>
                <c:pt idx="2">
                  <c:v>31.285714285714285</c:v>
                </c:pt>
                <c:pt idx="3">
                  <c:v>35.285714285714285</c:v>
                </c:pt>
                <c:pt idx="4">
                  <c:v>58.571428571428577</c:v>
                </c:pt>
                <c:pt idx="5">
                  <c:v>51.142857142857146</c:v>
                </c:pt>
                <c:pt idx="6">
                  <c:v>58.285714285714285</c:v>
                </c:pt>
                <c:pt idx="7">
                  <c:v>51.428571428571423</c:v>
                </c:pt>
                <c:pt idx="8">
                  <c:v>59</c:v>
                </c:pt>
                <c:pt idx="9">
                  <c:v>55.571428571428569</c:v>
                </c:pt>
                <c:pt idx="10">
                  <c:v>47.285714285714285</c:v>
                </c:pt>
                <c:pt idx="11">
                  <c:v>59.28571428571428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7209344"/>
        <c:axId val="117219328"/>
      </c:barChart>
      <c:catAx>
        <c:axId val="11720934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de-DE"/>
          </a:p>
        </c:txPr>
        <c:crossAx val="117219328"/>
        <c:crosses val="autoZero"/>
        <c:auto val="1"/>
        <c:lblAlgn val="ctr"/>
        <c:lblOffset val="100"/>
        <c:noMultiLvlLbl val="0"/>
      </c:catAx>
      <c:valAx>
        <c:axId val="117219328"/>
        <c:scaling>
          <c:orientation val="minMax"/>
          <c:max val="65"/>
          <c:min val="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>
                    <a:latin typeface="Arial" pitchFamily="34" charset="0"/>
                    <a:cs typeface="Arial" pitchFamily="34" charset="0"/>
                  </a:defRPr>
                </a:pPr>
                <a:r>
                  <a:rPr lang="en-US" dirty="0" smtClean="0">
                    <a:latin typeface="Arial" pitchFamily="34" charset="0"/>
                    <a:cs typeface="Arial" pitchFamily="34" charset="0"/>
                  </a:rPr>
                  <a:t>DNA Methylation </a:t>
                </a:r>
                <a:r>
                  <a:rPr lang="en-US" dirty="0">
                    <a:latin typeface="Arial" pitchFamily="34" charset="0"/>
                    <a:cs typeface="Arial" pitchFamily="34" charset="0"/>
                  </a:rPr>
                  <a:t>[%]</a:t>
                </a:r>
              </a:p>
            </c:rich>
          </c:tx>
          <c:layout>
            <c:manualLayout>
              <c:xMode val="edge"/>
              <c:yMode val="edge"/>
              <c:x val="3.4090909090909088E-2"/>
              <c:y val="3.0303030303030304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de-DE"/>
          </a:p>
        </c:txPr>
        <c:crossAx val="11720934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Itpka_3</c:v>
          </c:tx>
          <c:invertIfNegative val="0"/>
          <c:cat>
            <c:strRef>
              <c:f>Itpka_3!$D$18:$D$29</c:f>
              <c:strCache>
                <c:ptCount val="12"/>
                <c:pt idx="0">
                  <c:v>WT_LSK</c:v>
                </c:pt>
                <c:pt idx="1">
                  <c:v>WT_CMP</c:v>
                </c:pt>
                <c:pt idx="2">
                  <c:v>WT_GMP</c:v>
                </c:pt>
                <c:pt idx="3">
                  <c:v>WT_MEP</c:v>
                </c:pt>
                <c:pt idx="4">
                  <c:v>KD1_LSK</c:v>
                </c:pt>
                <c:pt idx="5">
                  <c:v>KD1_CMP</c:v>
                </c:pt>
                <c:pt idx="6">
                  <c:v>KD1_GMP</c:v>
                </c:pt>
                <c:pt idx="7">
                  <c:v>KD1_MEP</c:v>
                </c:pt>
                <c:pt idx="8">
                  <c:v>KD2_LSK</c:v>
                </c:pt>
                <c:pt idx="9">
                  <c:v>KD2_CMP</c:v>
                </c:pt>
                <c:pt idx="10">
                  <c:v>KD2_GMP</c:v>
                </c:pt>
                <c:pt idx="11">
                  <c:v>KD2_MEP</c:v>
                </c:pt>
              </c:strCache>
            </c:strRef>
          </c:cat>
          <c:val>
            <c:numRef>
              <c:f>Itpka_3!$E$18:$E$29</c:f>
              <c:numCache>
                <c:formatCode>General</c:formatCode>
                <c:ptCount val="12"/>
                <c:pt idx="0">
                  <c:v>12.142857142857141</c:v>
                </c:pt>
                <c:pt idx="1">
                  <c:v>13</c:v>
                </c:pt>
                <c:pt idx="2">
                  <c:v>10.142857142857144</c:v>
                </c:pt>
                <c:pt idx="3">
                  <c:v>11.001428571428571</c:v>
                </c:pt>
                <c:pt idx="4">
                  <c:v>17.714285714285712</c:v>
                </c:pt>
                <c:pt idx="5">
                  <c:v>16</c:v>
                </c:pt>
                <c:pt idx="6">
                  <c:v>16.571428571428569</c:v>
                </c:pt>
                <c:pt idx="7">
                  <c:v>13.999999999999998</c:v>
                </c:pt>
                <c:pt idx="8">
                  <c:v>16.857142857142858</c:v>
                </c:pt>
                <c:pt idx="9">
                  <c:v>19.285714285714285</c:v>
                </c:pt>
                <c:pt idx="10">
                  <c:v>15.714285714285717</c:v>
                </c:pt>
                <c:pt idx="11">
                  <c:v>1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7226880"/>
        <c:axId val="117245056"/>
      </c:barChart>
      <c:catAx>
        <c:axId val="11722688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de-DE"/>
          </a:p>
        </c:txPr>
        <c:crossAx val="117245056"/>
        <c:crosses val="autoZero"/>
        <c:auto val="1"/>
        <c:lblAlgn val="ctr"/>
        <c:lblOffset val="100"/>
        <c:noMultiLvlLbl val="0"/>
      </c:catAx>
      <c:valAx>
        <c:axId val="117245056"/>
        <c:scaling>
          <c:orientation val="minMax"/>
          <c:max val="2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>
                    <a:latin typeface="Arial" pitchFamily="34" charset="0"/>
                    <a:cs typeface="Arial" pitchFamily="34" charset="0"/>
                  </a:defRPr>
                </a:pPr>
                <a:r>
                  <a:rPr lang="en-US" dirty="0">
                    <a:latin typeface="Arial" pitchFamily="34" charset="0"/>
                    <a:cs typeface="Arial" pitchFamily="34" charset="0"/>
                  </a:rPr>
                  <a:t>DNA </a:t>
                </a:r>
                <a:r>
                  <a:rPr lang="en-US" dirty="0" smtClean="0">
                    <a:latin typeface="Arial" pitchFamily="34" charset="0"/>
                    <a:cs typeface="Arial" pitchFamily="34" charset="0"/>
                  </a:rPr>
                  <a:t>Methylation </a:t>
                </a:r>
                <a:r>
                  <a:rPr lang="en-US" dirty="0">
                    <a:latin typeface="Arial" pitchFamily="34" charset="0"/>
                    <a:cs typeface="Arial" pitchFamily="34" charset="0"/>
                  </a:rPr>
                  <a:t>[%]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de-DE"/>
          </a:p>
        </c:txPr>
        <c:crossAx val="117226880"/>
        <c:crosses val="autoZero"/>
        <c:crossBetween val="between"/>
        <c:majorUnit val="5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B678A-CCA6-4003-9EC8-E3DCD25C5C29}" type="datetimeFigureOut">
              <a:rPr lang="de-DE" smtClean="0"/>
              <a:t>22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D840E-B588-4A13-A7EE-88B7A4E8ED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909973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B678A-CCA6-4003-9EC8-E3DCD25C5C29}" type="datetimeFigureOut">
              <a:rPr lang="de-DE" smtClean="0"/>
              <a:t>22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D840E-B588-4A13-A7EE-88B7A4E8ED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99230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B678A-CCA6-4003-9EC8-E3DCD25C5C29}" type="datetimeFigureOut">
              <a:rPr lang="de-DE" smtClean="0"/>
              <a:t>22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D840E-B588-4A13-A7EE-88B7A4E8ED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765634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B678A-CCA6-4003-9EC8-E3DCD25C5C29}" type="datetimeFigureOut">
              <a:rPr lang="de-DE" smtClean="0"/>
              <a:t>22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D840E-B588-4A13-A7EE-88B7A4E8ED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42384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B678A-CCA6-4003-9EC8-E3DCD25C5C29}" type="datetimeFigureOut">
              <a:rPr lang="de-DE" smtClean="0"/>
              <a:t>22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D840E-B588-4A13-A7EE-88B7A4E8ED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0724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B678A-CCA6-4003-9EC8-E3DCD25C5C29}" type="datetimeFigureOut">
              <a:rPr lang="de-DE" smtClean="0"/>
              <a:t>22.03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D840E-B588-4A13-A7EE-88B7A4E8ED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13915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B678A-CCA6-4003-9EC8-E3DCD25C5C29}" type="datetimeFigureOut">
              <a:rPr lang="de-DE" smtClean="0"/>
              <a:t>22.03.201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D840E-B588-4A13-A7EE-88B7A4E8ED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827451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B678A-CCA6-4003-9EC8-E3DCD25C5C29}" type="datetimeFigureOut">
              <a:rPr lang="de-DE" smtClean="0"/>
              <a:t>22.03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D840E-B588-4A13-A7EE-88B7A4E8ED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069033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B678A-CCA6-4003-9EC8-E3DCD25C5C29}" type="datetimeFigureOut">
              <a:rPr lang="de-DE" smtClean="0"/>
              <a:t>22.03.201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D840E-B588-4A13-A7EE-88B7A4E8ED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005932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B678A-CCA6-4003-9EC8-E3DCD25C5C29}" type="datetimeFigureOut">
              <a:rPr lang="de-DE" smtClean="0"/>
              <a:t>22.03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D840E-B588-4A13-A7EE-88B7A4E8ED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225308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B678A-CCA6-4003-9EC8-E3DCD25C5C29}" type="datetimeFigureOut">
              <a:rPr lang="de-DE" smtClean="0"/>
              <a:t>22.03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D840E-B588-4A13-A7EE-88B7A4E8ED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983890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AB678A-CCA6-4003-9EC8-E3DCD25C5C29}" type="datetimeFigureOut">
              <a:rPr lang="de-DE" smtClean="0"/>
              <a:t>22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FD840E-B588-4A13-A7EE-88B7A4E8EDE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179959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image" Target="../media/image1.png"/><Relationship Id="rId7" Type="http://schemas.openxmlformats.org/officeDocument/2006/relationships/chart" Target="../charts/chart3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openxmlformats.org/officeDocument/2006/relationships/chart" Target="../charts/chart2.xml"/><Relationship Id="rId4" Type="http://schemas.openxmlformats.org/officeDocument/2006/relationships/image" Target="../media/image2.png"/><Relationship Id="rId9" Type="http://schemas.openxmlformats.org/officeDocument/2006/relationships/chart" Target="../charts/chart4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8.xml"/><Relationship Id="rId3" Type="http://schemas.openxmlformats.org/officeDocument/2006/relationships/chart" Target="../charts/chart5.xml"/><Relationship Id="rId7" Type="http://schemas.openxmlformats.org/officeDocument/2006/relationships/image" Target="../media/image7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7.xml"/><Relationship Id="rId5" Type="http://schemas.openxmlformats.org/officeDocument/2006/relationships/chart" Target="../charts/chart6.xml"/><Relationship Id="rId4" Type="http://schemas.openxmlformats.org/officeDocument/2006/relationships/image" Target="../media/image6.png"/><Relationship Id="rId9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Diagramm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93025504"/>
              </p:ext>
            </p:extLst>
          </p:nvPr>
        </p:nvGraphicFramePr>
        <p:xfrm>
          <a:off x="125593" y="1676401"/>
          <a:ext cx="3886200" cy="16733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15" name="Picture 2" descr="X:\PhD\Cell Sorting\MassARRAY results\Textfiles heatmaps\Prdm16.tiff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021" r="20064" b="40934"/>
          <a:stretch/>
        </p:blipFill>
        <p:spPr bwMode="auto">
          <a:xfrm>
            <a:off x="152400" y="892624"/>
            <a:ext cx="4150659" cy="7837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Textfeld 15"/>
          <p:cNvSpPr txBox="1"/>
          <p:nvPr/>
        </p:nvSpPr>
        <p:spPr>
          <a:xfrm>
            <a:off x="143522" y="457200"/>
            <a:ext cx="152400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500" dirty="0">
                <a:latin typeface="Arial" pitchFamily="34" charset="0"/>
                <a:cs typeface="Arial" pitchFamily="34" charset="0"/>
              </a:rPr>
              <a:t>A</a:t>
            </a:r>
            <a:r>
              <a:rPr lang="de-DE" sz="1500" dirty="0" smtClean="0">
                <a:latin typeface="Arial" pitchFamily="34" charset="0"/>
                <a:cs typeface="Arial" pitchFamily="34" charset="0"/>
              </a:rPr>
              <a:t>)  </a:t>
            </a:r>
            <a:r>
              <a:rPr lang="de-DE" sz="1500" b="1" i="1" dirty="0" smtClean="0">
                <a:latin typeface="Arial" pitchFamily="34" charset="0"/>
                <a:cs typeface="Arial" pitchFamily="34" charset="0"/>
              </a:rPr>
              <a:t>Prdm16</a:t>
            </a:r>
            <a:endParaRPr lang="de-DE" sz="1500" b="1" i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7" name="Picture 3" descr="X:\PhD\Cell Sorting\MassARRAY results\Textfiles heatmaps\Robo3.tiff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454" r="44876" b="42636"/>
          <a:stretch/>
        </p:blipFill>
        <p:spPr bwMode="auto">
          <a:xfrm>
            <a:off x="4724400" y="880623"/>
            <a:ext cx="3352800" cy="7957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Textfeld 17"/>
          <p:cNvSpPr txBox="1"/>
          <p:nvPr/>
        </p:nvSpPr>
        <p:spPr>
          <a:xfrm>
            <a:off x="4688541" y="457200"/>
            <a:ext cx="152400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500" dirty="0">
                <a:latin typeface="Arial" pitchFamily="34" charset="0"/>
                <a:cs typeface="Arial" pitchFamily="34" charset="0"/>
              </a:rPr>
              <a:t>B</a:t>
            </a:r>
            <a:r>
              <a:rPr lang="de-DE" sz="1500" dirty="0" smtClean="0">
                <a:latin typeface="Arial" pitchFamily="34" charset="0"/>
                <a:cs typeface="Arial" pitchFamily="34" charset="0"/>
              </a:rPr>
              <a:t>)  </a:t>
            </a:r>
            <a:r>
              <a:rPr lang="de-DE" sz="1500" b="1" i="1" dirty="0" smtClean="0">
                <a:latin typeface="Arial" pitchFamily="34" charset="0"/>
                <a:cs typeface="Arial" pitchFamily="34" charset="0"/>
              </a:rPr>
              <a:t>Robo3</a:t>
            </a:r>
            <a:endParaRPr lang="de-DE" sz="1500" b="1" i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9" name="Diagramm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12959378"/>
              </p:ext>
            </p:extLst>
          </p:nvPr>
        </p:nvGraphicFramePr>
        <p:xfrm>
          <a:off x="4724400" y="1725496"/>
          <a:ext cx="3810000" cy="16733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" name="Textfeld 5"/>
          <p:cNvSpPr txBox="1"/>
          <p:nvPr/>
        </p:nvSpPr>
        <p:spPr>
          <a:xfrm>
            <a:off x="152400" y="76200"/>
            <a:ext cx="89425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itchFamily="34" charset="0"/>
                <a:cs typeface="Arial" pitchFamily="34" charset="0"/>
              </a:rPr>
              <a:t>Additional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data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file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5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: 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DNA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methylation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levels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of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selected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genes in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sorted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bone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marrow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cells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of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PU.1-kd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and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–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wt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animals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181638" y="3505200"/>
            <a:ext cx="259080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500" dirty="0">
                <a:latin typeface="Arial" pitchFamily="34" charset="0"/>
                <a:cs typeface="Arial" pitchFamily="34" charset="0"/>
              </a:rPr>
              <a:t>C</a:t>
            </a:r>
            <a:r>
              <a:rPr lang="de-DE" sz="1500" dirty="0" smtClean="0">
                <a:latin typeface="Arial" pitchFamily="34" charset="0"/>
                <a:cs typeface="Arial" pitchFamily="34" charset="0"/>
              </a:rPr>
              <a:t>)  </a:t>
            </a:r>
            <a:r>
              <a:rPr lang="de-DE" sz="1500" b="1" i="1" dirty="0" err="1" smtClean="0">
                <a:latin typeface="Arial" pitchFamily="34" charset="0"/>
                <a:cs typeface="Arial" pitchFamily="34" charset="0"/>
              </a:rPr>
              <a:t>Bcor</a:t>
            </a:r>
            <a:r>
              <a:rPr lang="de-DE" sz="1500" b="1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500" b="1" i="1" dirty="0" err="1" smtClean="0">
                <a:latin typeface="Arial" pitchFamily="34" charset="0"/>
                <a:cs typeface="Arial" pitchFamily="34" charset="0"/>
              </a:rPr>
              <a:t>amplicon</a:t>
            </a:r>
            <a:r>
              <a:rPr lang="de-DE" sz="1500" b="1" i="1" dirty="0" smtClean="0">
                <a:latin typeface="Arial" pitchFamily="34" charset="0"/>
                <a:cs typeface="Arial" pitchFamily="34" charset="0"/>
              </a:rPr>
              <a:t> 1</a:t>
            </a:r>
            <a:endParaRPr lang="de-DE" sz="15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4717778" y="3509682"/>
            <a:ext cx="2321859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500" dirty="0">
                <a:latin typeface="Arial" pitchFamily="34" charset="0"/>
                <a:cs typeface="Arial" pitchFamily="34" charset="0"/>
              </a:rPr>
              <a:t>D</a:t>
            </a:r>
            <a:r>
              <a:rPr lang="de-DE" sz="1500" dirty="0" smtClean="0">
                <a:latin typeface="Arial" pitchFamily="34" charset="0"/>
                <a:cs typeface="Arial" pitchFamily="34" charset="0"/>
              </a:rPr>
              <a:t>)  </a:t>
            </a:r>
            <a:r>
              <a:rPr lang="de-DE" sz="1500" b="1" i="1" dirty="0" err="1" smtClean="0">
                <a:latin typeface="Arial" pitchFamily="34" charset="0"/>
                <a:cs typeface="Arial" pitchFamily="34" charset="0"/>
              </a:rPr>
              <a:t>Bcor</a:t>
            </a:r>
            <a:r>
              <a:rPr lang="de-DE" sz="1500" b="1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500" b="1" i="1" dirty="0" err="1" smtClean="0">
                <a:latin typeface="Arial" pitchFamily="34" charset="0"/>
                <a:cs typeface="Arial" pitchFamily="34" charset="0"/>
              </a:rPr>
              <a:t>amplicon</a:t>
            </a:r>
            <a:r>
              <a:rPr lang="de-DE" sz="1500" b="1" i="1" dirty="0" smtClean="0">
                <a:latin typeface="Arial" pitchFamily="34" charset="0"/>
                <a:cs typeface="Arial" pitchFamily="34" charset="0"/>
              </a:rPr>
              <a:t> 2</a:t>
            </a:r>
            <a:endParaRPr lang="de-DE" sz="1500" b="1" i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2" name="Picture 2" descr="X:\PhD\Cell Sorting\MassARRAY results\Textfiles heatmaps\Bcor_probe.tiff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861" r="24830" b="38542"/>
          <a:stretch/>
        </p:blipFill>
        <p:spPr bwMode="auto">
          <a:xfrm>
            <a:off x="210876" y="3828365"/>
            <a:ext cx="4085562" cy="11120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23" name="Diagramm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75593215"/>
              </p:ext>
            </p:extLst>
          </p:nvPr>
        </p:nvGraphicFramePr>
        <p:xfrm>
          <a:off x="153710" y="4940421"/>
          <a:ext cx="3761728" cy="16958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pic>
        <p:nvPicPr>
          <p:cNvPr id="24" name="Picture 3" descr="X:\PhD\Cell Sorting\MassARRAY results\Textfiles heatmaps\Bcor_2.tiff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480" r="65573" b="46839"/>
          <a:stretch/>
        </p:blipFill>
        <p:spPr bwMode="auto">
          <a:xfrm>
            <a:off x="4767644" y="3828365"/>
            <a:ext cx="2826685" cy="11120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25" name="Diagramm 2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77176880"/>
              </p:ext>
            </p:extLst>
          </p:nvPr>
        </p:nvGraphicFramePr>
        <p:xfrm>
          <a:off x="4767644" y="4962911"/>
          <a:ext cx="3567394" cy="16733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26" name="Textfeld 25"/>
          <p:cNvSpPr txBox="1"/>
          <p:nvPr/>
        </p:nvSpPr>
        <p:spPr>
          <a:xfrm rot="16200000">
            <a:off x="550979" y="2452096"/>
            <a:ext cx="5693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472613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feld 6"/>
          <p:cNvSpPr txBox="1"/>
          <p:nvPr/>
        </p:nvSpPr>
        <p:spPr>
          <a:xfrm>
            <a:off x="143522" y="134035"/>
            <a:ext cx="152400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500" dirty="0">
                <a:latin typeface="Arial" pitchFamily="34" charset="0"/>
                <a:cs typeface="Arial" pitchFamily="34" charset="0"/>
              </a:rPr>
              <a:t>E</a:t>
            </a:r>
            <a:r>
              <a:rPr lang="de-DE" sz="1500" dirty="0" smtClean="0">
                <a:latin typeface="Arial" pitchFamily="34" charset="0"/>
                <a:cs typeface="Arial" pitchFamily="34" charset="0"/>
              </a:rPr>
              <a:t>)  </a:t>
            </a:r>
            <a:r>
              <a:rPr lang="de-DE" sz="1500" b="1" i="1" dirty="0" smtClean="0">
                <a:latin typeface="Arial" pitchFamily="34" charset="0"/>
                <a:cs typeface="Arial" pitchFamily="34" charset="0"/>
              </a:rPr>
              <a:t>Hes6</a:t>
            </a:r>
            <a:endParaRPr lang="de-DE" sz="15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4688541" y="134035"/>
            <a:ext cx="152400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500" dirty="0">
                <a:latin typeface="Arial" pitchFamily="34" charset="0"/>
                <a:cs typeface="Arial" pitchFamily="34" charset="0"/>
              </a:rPr>
              <a:t>F</a:t>
            </a:r>
            <a:r>
              <a:rPr lang="de-DE" sz="1500" dirty="0" smtClean="0">
                <a:latin typeface="Arial" pitchFamily="34" charset="0"/>
                <a:cs typeface="Arial" pitchFamily="34" charset="0"/>
              </a:rPr>
              <a:t>)  </a:t>
            </a:r>
            <a:r>
              <a:rPr lang="de-DE" sz="1500" b="1" i="1" dirty="0" smtClean="0">
                <a:latin typeface="Arial" pitchFamily="34" charset="0"/>
                <a:cs typeface="Arial" pitchFamily="34" charset="0"/>
              </a:rPr>
              <a:t>Tal1</a:t>
            </a:r>
            <a:endParaRPr lang="de-DE" sz="1500" b="1" i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6" name="Picture 2" descr="X:\PhD\Cell Sorting\MassARRAY results\Textfiles heatmaps\Hes6.tif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925" r="53900" b="45314"/>
          <a:stretch/>
        </p:blipFill>
        <p:spPr bwMode="auto">
          <a:xfrm>
            <a:off x="181638" y="457200"/>
            <a:ext cx="3704562" cy="104417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17" name="Diagramm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17389530"/>
              </p:ext>
            </p:extLst>
          </p:nvPr>
        </p:nvGraphicFramePr>
        <p:xfrm>
          <a:off x="143522" y="1501379"/>
          <a:ext cx="3514078" cy="17046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18" name="Picture 2" descr="X:\PhD\Cell Sorting\MassARRAY results\Textfiles heatmaps\Tal1_ohneCpG6.tiff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096" r="29243" b="36986"/>
          <a:stretch/>
        </p:blipFill>
        <p:spPr bwMode="auto">
          <a:xfrm>
            <a:off x="4738406" y="503126"/>
            <a:ext cx="4405594" cy="10077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19" name="Diagramm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02412009"/>
              </p:ext>
            </p:extLst>
          </p:nvPr>
        </p:nvGraphicFramePr>
        <p:xfrm>
          <a:off x="4800600" y="1605802"/>
          <a:ext cx="3505200" cy="1752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20" name="Gruppieren 19"/>
          <p:cNvGrpSpPr/>
          <p:nvPr/>
        </p:nvGrpSpPr>
        <p:grpSpPr>
          <a:xfrm>
            <a:off x="246893" y="3578119"/>
            <a:ext cx="8211307" cy="3279881"/>
            <a:chOff x="152400" y="69337"/>
            <a:chExt cx="8211307" cy="3279881"/>
          </a:xfrm>
        </p:grpSpPr>
        <p:graphicFrame>
          <p:nvGraphicFramePr>
            <p:cNvPr id="21" name="Diagramm 2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23272720"/>
                </p:ext>
              </p:extLst>
            </p:nvPr>
          </p:nvGraphicFramePr>
          <p:xfrm>
            <a:off x="304800" y="1510893"/>
            <a:ext cx="3352800" cy="16764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pic>
          <p:nvPicPr>
            <p:cNvPr id="22" name="Picture 2" descr="X:\PhD\Cell Sorting\MassARRAY results\Textfiles heatmaps\Itpka_2.tiff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7716" r="55452" b="39360"/>
            <a:stretch/>
          </p:blipFill>
          <p:spPr bwMode="auto">
            <a:xfrm>
              <a:off x="381000" y="457200"/>
              <a:ext cx="3429000" cy="105369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aphicFrame>
          <p:nvGraphicFramePr>
            <p:cNvPr id="23" name="Diagramm 2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59467727"/>
                </p:ext>
              </p:extLst>
            </p:nvPr>
          </p:nvGraphicFramePr>
          <p:xfrm>
            <a:off x="4679015" y="1503344"/>
            <a:ext cx="3276600" cy="184587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pic>
          <p:nvPicPr>
            <p:cNvPr id="24" name="Picture 3" descr="X:\PhD\Cell Sorting\MassARRAY results\Textfiles heatmaps\Itpka_3.tiff"/>
            <p:cNvPicPr>
              <a:picLocks noChangeAspect="1" noChangeArrowheads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2127" r="55824" b="44924"/>
            <a:stretch/>
          </p:blipFill>
          <p:spPr bwMode="auto">
            <a:xfrm>
              <a:off x="4679015" y="411552"/>
              <a:ext cx="3684692" cy="114299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5" name="Textfeld 24"/>
            <p:cNvSpPr txBox="1"/>
            <p:nvPr/>
          </p:nvSpPr>
          <p:spPr>
            <a:xfrm>
              <a:off x="152400" y="69337"/>
              <a:ext cx="259080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500" dirty="0">
                  <a:latin typeface="Arial" pitchFamily="34" charset="0"/>
                  <a:cs typeface="Arial" pitchFamily="34" charset="0"/>
                </a:rPr>
                <a:t>G</a:t>
              </a:r>
              <a:r>
                <a:rPr lang="de-DE" sz="1500" dirty="0" smtClean="0">
                  <a:latin typeface="Arial" pitchFamily="34" charset="0"/>
                  <a:cs typeface="Arial" pitchFamily="34" charset="0"/>
                </a:rPr>
                <a:t>)  </a:t>
              </a:r>
              <a:r>
                <a:rPr lang="de-DE" sz="1500" b="1" i="1" dirty="0" err="1" smtClean="0">
                  <a:latin typeface="Arial" pitchFamily="34" charset="0"/>
                  <a:cs typeface="Arial" pitchFamily="34" charset="0"/>
                </a:rPr>
                <a:t>Itpka</a:t>
              </a:r>
              <a:r>
                <a:rPr lang="de-DE" sz="1500" b="1" i="1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1500" b="1" i="1" dirty="0" err="1" smtClean="0">
                  <a:latin typeface="Arial" pitchFamily="34" charset="0"/>
                  <a:cs typeface="Arial" pitchFamily="34" charset="0"/>
                </a:rPr>
                <a:t>amplicon</a:t>
              </a:r>
              <a:r>
                <a:rPr lang="de-DE" sz="1500" b="1" i="1" dirty="0" smtClean="0">
                  <a:latin typeface="Arial" pitchFamily="34" charset="0"/>
                  <a:cs typeface="Arial" pitchFamily="34" charset="0"/>
                </a:rPr>
                <a:t> 1</a:t>
              </a:r>
              <a:endParaRPr lang="de-DE" sz="1500" b="1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Textfeld 25"/>
            <p:cNvSpPr txBox="1"/>
            <p:nvPr/>
          </p:nvSpPr>
          <p:spPr>
            <a:xfrm>
              <a:off x="4688540" y="73819"/>
              <a:ext cx="2321859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500" dirty="0">
                  <a:latin typeface="Arial" pitchFamily="34" charset="0"/>
                  <a:cs typeface="Arial" pitchFamily="34" charset="0"/>
                </a:rPr>
                <a:t>H</a:t>
              </a:r>
              <a:r>
                <a:rPr lang="de-DE" sz="1500" dirty="0" smtClean="0">
                  <a:latin typeface="Arial" pitchFamily="34" charset="0"/>
                  <a:cs typeface="Arial" pitchFamily="34" charset="0"/>
                </a:rPr>
                <a:t>)  </a:t>
              </a:r>
              <a:r>
                <a:rPr lang="de-DE" sz="1500" b="1" i="1" dirty="0" err="1" smtClean="0">
                  <a:latin typeface="Arial" pitchFamily="34" charset="0"/>
                  <a:cs typeface="Arial" pitchFamily="34" charset="0"/>
                </a:rPr>
                <a:t>Itpka</a:t>
              </a:r>
              <a:r>
                <a:rPr lang="de-DE" sz="1500" b="1" i="1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1500" b="1" i="1" dirty="0" err="1" smtClean="0">
                  <a:latin typeface="Arial" pitchFamily="34" charset="0"/>
                  <a:cs typeface="Arial" pitchFamily="34" charset="0"/>
                </a:rPr>
                <a:t>amplicon</a:t>
              </a:r>
              <a:r>
                <a:rPr lang="de-DE" sz="1500" b="1" i="1" dirty="0" smtClean="0">
                  <a:latin typeface="Arial" pitchFamily="34" charset="0"/>
                  <a:cs typeface="Arial" pitchFamily="34" charset="0"/>
                </a:rPr>
                <a:t> 2</a:t>
              </a:r>
              <a:endParaRPr lang="de-DE" sz="1500" b="1" i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5" name="Textfeld 14"/>
          <p:cNvSpPr txBox="1"/>
          <p:nvPr/>
        </p:nvSpPr>
        <p:spPr>
          <a:xfrm rot="16200000">
            <a:off x="776873" y="2296527"/>
            <a:ext cx="5693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598005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228600" y="304800"/>
            <a:ext cx="8286751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Methylation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level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displayed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a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heatmap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above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)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and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bar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graph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below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)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of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amplicon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from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genes </a:t>
            </a:r>
            <a:r>
              <a:rPr lang="de-DE" sz="1200" i="1" dirty="0" smtClean="0">
                <a:latin typeface="Arial" pitchFamily="34" charset="0"/>
                <a:cs typeface="Arial" pitchFamily="34" charset="0"/>
              </a:rPr>
              <a:t>Prdm16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(A), </a:t>
            </a:r>
            <a:r>
              <a:rPr lang="de-DE" sz="1200" i="1" dirty="0" smtClean="0">
                <a:latin typeface="Arial" pitchFamily="34" charset="0"/>
                <a:cs typeface="Arial" pitchFamily="34" charset="0"/>
              </a:rPr>
              <a:t>Robo3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(B), </a:t>
            </a:r>
            <a:r>
              <a:rPr lang="de-DE" sz="1200" i="1" dirty="0" err="1" smtClean="0">
                <a:latin typeface="Arial" pitchFamily="34" charset="0"/>
                <a:cs typeface="Arial" pitchFamily="34" charset="0"/>
              </a:rPr>
              <a:t>Bcor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(C+D), </a:t>
            </a:r>
            <a:r>
              <a:rPr lang="de-DE" sz="1200" i="1" dirty="0" smtClean="0">
                <a:latin typeface="Arial" pitchFamily="34" charset="0"/>
                <a:cs typeface="Arial" pitchFamily="34" charset="0"/>
              </a:rPr>
              <a:t>Hes6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(E), </a:t>
            </a:r>
            <a:r>
              <a:rPr lang="de-DE" sz="1200" i="1" dirty="0" smtClean="0">
                <a:latin typeface="Arial" pitchFamily="34" charset="0"/>
                <a:cs typeface="Arial" pitchFamily="34" charset="0"/>
              </a:rPr>
              <a:t>Tal1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(F)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and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i="1" dirty="0" err="1" smtClean="0">
                <a:latin typeface="Arial" pitchFamily="34" charset="0"/>
                <a:cs typeface="Arial" pitchFamily="34" charset="0"/>
              </a:rPr>
              <a:t>Itpka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(G+H). The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sorted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cell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comprise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LSKs (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Lineage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negative, Ska1-positive, c-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kit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negative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cell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), CMPs (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common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myeloid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progenitor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cell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), GMPs (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granulocyte-macrophage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progenitor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cell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)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and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MEPs (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megakaryocyte-erythroid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progenitor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cell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). The PU.1-wt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contain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a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pool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of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five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PU.1-wt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animal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the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two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preleukemic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PU.1-kd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group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(KD1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and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KD2)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contain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pool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of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four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mice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for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each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Heatmap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display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single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CpG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unit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column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)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of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PU.1-kd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or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PU.1-wt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animal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row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).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Methylation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value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range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from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0% (light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green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)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to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100% (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dark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blue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). Bar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graph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show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average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methylation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(y-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axi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)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of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the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different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amplicon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. In 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A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and</a:t>
            </a:r>
            <a:r>
              <a:rPr lang="de-DE" sz="1200" smtClean="0">
                <a:latin typeface="Arial" pitchFamily="34" charset="0"/>
                <a:cs typeface="Arial" pitchFamily="34" charset="0"/>
              </a:rPr>
              <a:t> E,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analysi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of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each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a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single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group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failed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indicated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by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grey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CpG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unit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in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the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respective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heatmap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and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missing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value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in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the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 bar </a:t>
            </a:r>
            <a:r>
              <a:rPr lang="de-DE" sz="1200" dirty="0" err="1" smtClean="0">
                <a:latin typeface="Arial" pitchFamily="34" charset="0"/>
                <a:cs typeface="Arial" pitchFamily="34" charset="0"/>
              </a:rPr>
              <a:t>graphs</a:t>
            </a:r>
            <a:r>
              <a:rPr lang="de-DE" sz="1200" dirty="0" smtClean="0">
                <a:latin typeface="Arial" pitchFamily="34" charset="0"/>
                <a:cs typeface="Arial" pitchFamily="34" charset="0"/>
              </a:rPr>
              <a:t>.</a:t>
            </a:r>
            <a:endParaRPr lang="de-DE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371245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6</Words>
  <Application>Microsoft Office PowerPoint</Application>
  <PresentationFormat>Bildschirmpräsentation (4:3)</PresentationFormat>
  <Paragraphs>20</Paragraphs>
  <Slides>3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4" baseType="lpstr">
      <vt:lpstr>Larissa</vt:lpstr>
      <vt:lpstr>PowerPoint-Präsentation</vt:lpstr>
      <vt:lpstr>PowerPoint-Präsentation</vt:lpstr>
      <vt:lpstr>PowerPoint-Präsentation</vt:lpstr>
    </vt:vector>
  </TitlesOfParts>
  <Company>DKFZ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onnet</dc:creator>
  <cp:lastModifiedBy>Weichenhan, Dieter</cp:lastModifiedBy>
  <cp:revision>27</cp:revision>
  <dcterms:created xsi:type="dcterms:W3CDTF">2013-08-09T11:32:03Z</dcterms:created>
  <dcterms:modified xsi:type="dcterms:W3CDTF">2014-03-22T12:17:30Z</dcterms:modified>
</cp:coreProperties>
</file>